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684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673F1-3ECE-475C-913A-BCE40BB63BD9}" type="datetimeFigureOut">
              <a:rPr lang="de-DE" smtClean="0"/>
              <a:t>30.01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A659A3-603C-4964-982D-712C9C22C83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158829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673F1-3ECE-475C-913A-BCE40BB63BD9}" type="datetimeFigureOut">
              <a:rPr lang="de-DE" smtClean="0"/>
              <a:t>30.01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A659A3-603C-4964-982D-712C9C22C83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76486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673F1-3ECE-475C-913A-BCE40BB63BD9}" type="datetimeFigureOut">
              <a:rPr lang="de-DE" smtClean="0"/>
              <a:t>30.01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A659A3-603C-4964-982D-712C9C22C83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83435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673F1-3ECE-475C-913A-BCE40BB63BD9}" type="datetimeFigureOut">
              <a:rPr lang="de-DE" smtClean="0"/>
              <a:t>30.01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A659A3-603C-4964-982D-712C9C22C83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619416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673F1-3ECE-475C-913A-BCE40BB63BD9}" type="datetimeFigureOut">
              <a:rPr lang="de-DE" smtClean="0"/>
              <a:t>30.01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A659A3-603C-4964-982D-712C9C22C83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417929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673F1-3ECE-475C-913A-BCE40BB63BD9}" type="datetimeFigureOut">
              <a:rPr lang="de-DE" smtClean="0"/>
              <a:t>30.01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A659A3-603C-4964-982D-712C9C22C83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310646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673F1-3ECE-475C-913A-BCE40BB63BD9}" type="datetimeFigureOut">
              <a:rPr lang="de-DE" smtClean="0"/>
              <a:t>30.01.202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A659A3-603C-4964-982D-712C9C22C83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565960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673F1-3ECE-475C-913A-BCE40BB63BD9}" type="datetimeFigureOut">
              <a:rPr lang="de-DE" smtClean="0"/>
              <a:t>30.01.202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A659A3-603C-4964-982D-712C9C22C83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401397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673F1-3ECE-475C-913A-BCE40BB63BD9}" type="datetimeFigureOut">
              <a:rPr lang="de-DE" smtClean="0"/>
              <a:t>30.01.202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A659A3-603C-4964-982D-712C9C22C83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753517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673F1-3ECE-475C-913A-BCE40BB63BD9}" type="datetimeFigureOut">
              <a:rPr lang="de-DE" smtClean="0"/>
              <a:t>30.01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A659A3-603C-4964-982D-712C9C22C83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276792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673F1-3ECE-475C-913A-BCE40BB63BD9}" type="datetimeFigureOut">
              <a:rPr lang="de-DE" smtClean="0"/>
              <a:t>30.01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A659A3-603C-4964-982D-712C9C22C83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26419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F673F1-3ECE-475C-913A-BCE40BB63BD9}" type="datetimeFigureOut">
              <a:rPr lang="de-DE" smtClean="0"/>
              <a:t>30.01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A659A3-603C-4964-982D-712C9C22C83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564069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Grafik 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4581" y="4725273"/>
            <a:ext cx="4110236" cy="812294"/>
          </a:xfrm>
          <a:prstGeom prst="rect">
            <a:avLst/>
          </a:prstGeom>
        </p:spPr>
      </p:pic>
      <p:pic>
        <p:nvPicPr>
          <p:cNvPr id="2" name="Grafik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5623" y="2848568"/>
            <a:ext cx="4331217" cy="1636779"/>
          </a:xfrm>
          <a:prstGeom prst="rect">
            <a:avLst/>
          </a:prstGeom>
        </p:spPr>
      </p:pic>
      <p:pic>
        <p:nvPicPr>
          <p:cNvPr id="9" name="Grafik 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5622" y="1342413"/>
            <a:ext cx="4331217" cy="1365507"/>
          </a:xfrm>
          <a:prstGeom prst="rect">
            <a:avLst/>
          </a:prstGeom>
        </p:spPr>
      </p:pic>
      <p:sp>
        <p:nvSpPr>
          <p:cNvPr id="3" name="Textfeld 2"/>
          <p:cNvSpPr txBox="1"/>
          <p:nvPr/>
        </p:nvSpPr>
        <p:spPr>
          <a:xfrm>
            <a:off x="2814221" y="1342413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2801397" y="284856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feld 3"/>
          <p:cNvSpPr txBox="1"/>
          <p:nvPr/>
        </p:nvSpPr>
        <p:spPr>
          <a:xfrm>
            <a:off x="506028" y="239697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</a:p>
        </p:txBody>
      </p:sp>
    </p:spTree>
    <p:extLst>
      <p:ext uri="{BB962C8B-B14F-4D97-AF65-F5344CB8AC3E}">
        <p14:creationId xmlns:p14="http://schemas.microsoft.com/office/powerpoint/2010/main" val="18541675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96480954"/>
              </p:ext>
            </p:extLst>
          </p:nvPr>
        </p:nvGraphicFramePr>
        <p:xfrm>
          <a:off x="3123952" y="520841"/>
          <a:ext cx="5150035" cy="620121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705499">
                  <a:extLst>
                    <a:ext uri="{9D8B030D-6E8A-4147-A177-3AD203B41FA5}">
                      <a16:colId xmlns:a16="http://schemas.microsoft.com/office/drawing/2014/main" val="3938726987"/>
                    </a:ext>
                  </a:extLst>
                </a:gridCol>
                <a:gridCol w="1553592">
                  <a:extLst>
                    <a:ext uri="{9D8B030D-6E8A-4147-A177-3AD203B41FA5}">
                      <a16:colId xmlns:a16="http://schemas.microsoft.com/office/drawing/2014/main" val="579486797"/>
                    </a:ext>
                  </a:extLst>
                </a:gridCol>
                <a:gridCol w="1890944">
                  <a:extLst>
                    <a:ext uri="{9D8B030D-6E8A-4147-A177-3AD203B41FA5}">
                      <a16:colId xmlns:a16="http://schemas.microsoft.com/office/drawing/2014/main" val="3829869050"/>
                    </a:ext>
                  </a:extLst>
                </a:gridCol>
              </a:tblGrid>
              <a:tr h="638617">
                <a:tc>
                  <a:txBody>
                    <a:bodyPr/>
                    <a:lstStyle/>
                    <a:p>
                      <a:r>
                        <a:rPr lang="de-DE" sz="1200" b="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scle</a:t>
                      </a:r>
                      <a:r>
                        <a:rPr lang="de-DE" sz="1200" b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tatus</a:t>
                      </a:r>
                      <a:endParaRPr lang="de-DE" sz="12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de-DE" sz="12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200" b="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t</a:t>
                      </a:r>
                      <a:r>
                        <a:rPr lang="de-DE" sz="1200" b="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200" b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ree </a:t>
                      </a:r>
                      <a:r>
                        <a:rPr lang="de-DE" sz="1200" b="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scle</a:t>
                      </a:r>
                      <a:endParaRPr lang="de-DE" sz="1200" b="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200" b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200" b="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raction</a:t>
                      </a:r>
                      <a:endParaRPr lang="de-DE" sz="1200" b="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968666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de-DE" sz="120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r>
                        <a:rPr lang="de-D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20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scle</a:t>
                      </a:r>
                      <a:r>
                        <a:rPr lang="de-D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200" baseline="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ss</a:t>
                      </a:r>
                      <a:endParaRPr lang="de-D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</a:t>
                      </a:r>
                      <a:endParaRPr lang="de-D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271250</a:t>
                      </a:r>
                      <a:endParaRPr lang="de-D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3392891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de-D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imum</a:t>
                      </a:r>
                      <a:endParaRPr lang="de-D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2586</a:t>
                      </a:r>
                      <a:endParaRPr lang="de-D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4899544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de-D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ximum</a:t>
                      </a:r>
                      <a:endParaRPr lang="de-D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7346</a:t>
                      </a:r>
                      <a:endParaRPr lang="de-D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1464565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de-D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20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  <a:r>
                        <a:rPr lang="de-D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20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lue</a:t>
                      </a:r>
                      <a:endParaRPr lang="de-D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426133</a:t>
                      </a:r>
                      <a:endParaRPr lang="de-D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9730501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de-DE" sz="12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d. </a:t>
                      </a:r>
                      <a:r>
                        <a:rPr lang="de-DE" sz="120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viation</a:t>
                      </a:r>
                      <a:endParaRPr lang="de-D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1336398</a:t>
                      </a:r>
                      <a:endParaRPr lang="de-D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3968940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de-DE" sz="120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scle</a:t>
                      </a:r>
                      <a:r>
                        <a:rPr lang="de-D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20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ss</a:t>
                      </a:r>
                      <a:endParaRPr lang="de-D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</a:t>
                      </a:r>
                      <a:endParaRPr lang="de-D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782800</a:t>
                      </a:r>
                      <a:endParaRPr lang="de-D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1560879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de-D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imum</a:t>
                      </a:r>
                      <a:endParaRPr lang="de-D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2019</a:t>
                      </a:r>
                      <a:endParaRPr lang="de-D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002435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de-D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ximum</a:t>
                      </a:r>
                      <a:endParaRPr lang="de-D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4515</a:t>
                      </a:r>
                      <a:endParaRPr lang="de-D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6415641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de-D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20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  <a:r>
                        <a:rPr lang="de-D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20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lue</a:t>
                      </a:r>
                      <a:endParaRPr lang="de-D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652780</a:t>
                      </a:r>
                      <a:endParaRPr lang="de-D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2811745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de-D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d. </a:t>
                      </a:r>
                      <a:r>
                        <a:rPr lang="de-DE" sz="120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viation</a:t>
                      </a:r>
                      <a:endParaRPr lang="de-D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2227334</a:t>
                      </a:r>
                      <a:endParaRPr lang="de-D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2276679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de-D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verall</a:t>
                      </a:r>
                      <a:endParaRPr lang="de-D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</a:t>
                      </a:r>
                      <a:endParaRPr lang="de-D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782800</a:t>
                      </a:r>
                      <a:endParaRPr lang="de-D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7886762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de-D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imum</a:t>
                      </a:r>
                      <a:endParaRPr lang="de-D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2019</a:t>
                      </a:r>
                      <a:endParaRPr lang="de-D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774820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de-D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ximum</a:t>
                      </a:r>
                      <a:endParaRPr lang="de-D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7346</a:t>
                      </a:r>
                      <a:endParaRPr lang="de-D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9486602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de-D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20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  <a:r>
                        <a:rPr lang="de-D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20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lue</a:t>
                      </a:r>
                      <a:endParaRPr lang="de-D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873738</a:t>
                      </a:r>
                      <a:endParaRPr lang="de-D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717863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de-D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d. </a:t>
                      </a:r>
                      <a:r>
                        <a:rPr lang="de-DE" sz="120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viation</a:t>
                      </a:r>
                      <a:endParaRPr lang="de-D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2231099</a:t>
                      </a:r>
                      <a:endParaRPr lang="de-D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6589513"/>
                  </a:ext>
                </a:extLst>
              </a:tr>
            </a:tbl>
          </a:graphicData>
        </a:graphic>
      </p:graphicFrame>
      <p:sp>
        <p:nvSpPr>
          <p:cNvPr id="3" name="Textfeld 2"/>
          <p:cNvSpPr txBox="1"/>
          <p:nvPr/>
        </p:nvSpPr>
        <p:spPr>
          <a:xfrm>
            <a:off x="292963" y="213064"/>
            <a:ext cx="9071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smtClean="0">
                <a:latin typeface="Arial" panose="020B0604020202020204" pitchFamily="34" charset="0"/>
                <a:cs typeface="Arial" panose="020B0604020202020204" pitchFamily="34" charset="0"/>
              </a:rPr>
              <a:t>Table </a:t>
            </a:r>
            <a:r>
              <a:rPr lang="de-DE" sz="1400" b="1" smtClean="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feld 3"/>
          <p:cNvSpPr txBox="1"/>
          <p:nvPr/>
        </p:nvSpPr>
        <p:spPr>
          <a:xfrm>
            <a:off x="4678532" y="100622"/>
            <a:ext cx="22910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at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Free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uscle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raction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9552373" y="852256"/>
            <a:ext cx="9444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P=0.198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4029109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3</Words>
  <Application>Microsoft Office PowerPoint</Application>
  <PresentationFormat>Breitbild</PresentationFormat>
  <Paragraphs>42</Paragraphs>
  <Slides>2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Nowak Sebastian</dc:creator>
  <cp:lastModifiedBy>Sadeghlar, Dr. Farsaneh</cp:lastModifiedBy>
  <cp:revision>13</cp:revision>
  <dcterms:created xsi:type="dcterms:W3CDTF">2024-01-16T10:30:27Z</dcterms:created>
  <dcterms:modified xsi:type="dcterms:W3CDTF">2024-01-30T14:23:44Z</dcterms:modified>
</cp:coreProperties>
</file>